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8" r:id="rId2"/>
    <p:sldId id="279" r:id="rId3"/>
    <p:sldId id="280" r:id="rId4"/>
    <p:sldId id="281" r:id="rId5"/>
    <p:sldId id="282" r:id="rId6"/>
    <p:sldId id="283" r:id="rId7"/>
    <p:sldId id="285" r:id="rId8"/>
  </p:sldIdLst>
  <p:sldSz cx="12192000" cy="6858000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9"/>
    <p:restoredTop sz="96208"/>
  </p:normalViewPr>
  <p:slideViewPr>
    <p:cSldViewPr snapToGrid="0" snapToObjects="1">
      <p:cViewPr>
        <p:scale>
          <a:sx n="90" d="100"/>
          <a:sy n="90" d="100"/>
        </p:scale>
        <p:origin x="-348" y="-55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A0804A33-11C3-6743-A3EF-9BB2225D019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Подзаголовок 2">
            <a:extLst>
              <a:ext uri="{FF2B5EF4-FFF2-40B4-BE49-F238E27FC236}">
                <a16:creationId xmlns="" xmlns:a16="http://schemas.microsoft.com/office/drawing/2014/main" id="{FCB8B1C9-D61A-6346-9F8D-4C0730C3CA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/>
              <a:t>Образец подзаголовк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389D3B86-1F5C-6940-97DD-0FABBA0462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92ACC-4BC5-674E-BD03-71A472ABDE82}" type="datetimeFigureOut">
              <a:rPr lang="ru-RU" smtClean="0"/>
              <a:t>26.11.2021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321CFCEA-7B02-1345-8174-6C9E2D10A8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D8F055B0-D13F-2A40-B471-3F240DE8FB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94E17-15EA-254D-A7DA-47895961C57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1843196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AFECFCC1-940D-0B46-8ED0-F02494D9F4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="" xmlns:a16="http://schemas.microsoft.com/office/drawing/2014/main" id="{D817D189-F5E7-AA43-990A-1352B96ED6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44639348-7AEB-C24E-B211-AA13E38717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92ACC-4BC5-674E-BD03-71A472ABDE82}" type="datetimeFigureOut">
              <a:rPr lang="ru-RU" smtClean="0"/>
              <a:t>26.11.2021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5F229B3A-521E-1748-AA36-5666B3133E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6BB77748-E400-A744-B28E-FCE8501EDB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94E17-15EA-254D-A7DA-47895961C57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7243907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>
            <a:extLst>
              <a:ext uri="{FF2B5EF4-FFF2-40B4-BE49-F238E27FC236}">
                <a16:creationId xmlns="" xmlns:a16="http://schemas.microsoft.com/office/drawing/2014/main" id="{A2FAF827-AD3C-1743-A8CF-F03B6BD18BD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="" xmlns:a16="http://schemas.microsoft.com/office/drawing/2014/main" id="{53F3C68D-31BD-5147-9C9F-40124E2502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E04946D4-6C9D-A348-A3D6-157E54A7DC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92ACC-4BC5-674E-BD03-71A472ABDE82}" type="datetimeFigureOut">
              <a:rPr lang="ru-RU" smtClean="0"/>
              <a:t>26.11.2021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6E625749-4687-8E40-8A26-C4D2895EA8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ECA936F3-8616-BE4B-908D-1EA880DF93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94E17-15EA-254D-A7DA-47895961C57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480320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EF31AD8A-1CF9-224D-98F4-F5009600BB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E252A4A6-F497-FC4E-A701-2084A0C26F3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8379F744-5987-1B45-9D24-5C6745002D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92ACC-4BC5-674E-BD03-71A472ABDE82}" type="datetimeFigureOut">
              <a:rPr lang="ru-RU" smtClean="0"/>
              <a:t>26.11.2021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95E01AF9-6094-BB43-A7DF-FE20D8E601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A0DA3608-792F-1B47-978A-746A075337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94E17-15EA-254D-A7DA-47895961C57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6038756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A04F85D7-82B8-8146-A8C4-1AE73E4CD2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="" xmlns:a16="http://schemas.microsoft.com/office/drawing/2014/main" id="{CDAD3257-1A22-BE49-B81F-BD99182655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652304BB-5DCA-C545-8009-2095DB6D9A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92ACC-4BC5-674E-BD03-71A472ABDE82}" type="datetimeFigureOut">
              <a:rPr lang="ru-RU" smtClean="0"/>
              <a:t>26.11.2021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772ED9A6-DC66-944B-9D95-FA557083C1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B5377847-7EE4-5A4F-8F56-AE6B006002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94E17-15EA-254D-A7DA-47895961C57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6027573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941BB4B9-47EB-9F4C-AD8B-D1FF579262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A6FCD989-E280-F64E-B403-0477763CCE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="" xmlns:a16="http://schemas.microsoft.com/office/drawing/2014/main" id="{DDB3BB77-BB9B-BA41-B2D2-E8FEF5BF70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="" xmlns:a16="http://schemas.microsoft.com/office/drawing/2014/main" id="{B33A8775-515B-FB47-9ED2-40069A561B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92ACC-4BC5-674E-BD03-71A472ABDE82}" type="datetimeFigureOut">
              <a:rPr lang="ru-RU" smtClean="0"/>
              <a:t>26.11.2021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="" xmlns:a16="http://schemas.microsoft.com/office/drawing/2014/main" id="{AF83439E-1CBC-0443-9656-A960ACD8FC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="" xmlns:a16="http://schemas.microsoft.com/office/drawing/2014/main" id="{B00CFCD3-0384-AB47-B950-079F0445A9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94E17-15EA-254D-A7DA-47895961C57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286629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E9FAD54E-1058-9644-93F0-90A91A4110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="" xmlns:a16="http://schemas.microsoft.com/office/drawing/2014/main" id="{7420F93B-5B01-7B41-8C17-BF683A0052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="" xmlns:a16="http://schemas.microsoft.com/office/drawing/2014/main" id="{61EEEDBF-65A7-AD40-AAC6-942615FB06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Текст 4">
            <a:extLst>
              <a:ext uri="{FF2B5EF4-FFF2-40B4-BE49-F238E27FC236}">
                <a16:creationId xmlns="" xmlns:a16="http://schemas.microsoft.com/office/drawing/2014/main" id="{F96B351A-51A8-8E47-B513-EC6E1ACEC93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Объект 5">
            <a:extLst>
              <a:ext uri="{FF2B5EF4-FFF2-40B4-BE49-F238E27FC236}">
                <a16:creationId xmlns="" xmlns:a16="http://schemas.microsoft.com/office/drawing/2014/main" id="{07296DF9-243D-6548-93C6-6207EE58DA2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7" name="Дата 6">
            <a:extLst>
              <a:ext uri="{FF2B5EF4-FFF2-40B4-BE49-F238E27FC236}">
                <a16:creationId xmlns="" xmlns:a16="http://schemas.microsoft.com/office/drawing/2014/main" id="{6FE4A31D-595E-CC4D-9CDD-9450DC63F0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92ACC-4BC5-674E-BD03-71A472ABDE82}" type="datetimeFigureOut">
              <a:rPr lang="ru-RU" smtClean="0"/>
              <a:t>26.11.2021</a:t>
            </a:fld>
            <a:endParaRPr lang="ru-RU"/>
          </a:p>
        </p:txBody>
      </p:sp>
      <p:sp>
        <p:nvSpPr>
          <p:cNvPr id="8" name="Нижний колонтитул 7">
            <a:extLst>
              <a:ext uri="{FF2B5EF4-FFF2-40B4-BE49-F238E27FC236}">
                <a16:creationId xmlns="" xmlns:a16="http://schemas.microsoft.com/office/drawing/2014/main" id="{9298FBF7-725E-C644-B6F6-EF45C697BB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>
            <a:extLst>
              <a:ext uri="{FF2B5EF4-FFF2-40B4-BE49-F238E27FC236}">
                <a16:creationId xmlns="" xmlns:a16="http://schemas.microsoft.com/office/drawing/2014/main" id="{46BB4522-6FB7-C246-923A-4F2993F5BD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94E17-15EA-254D-A7DA-47895961C57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994829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C4131E6E-6872-3A4D-8B0D-1FD1BFA898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Дата 2">
            <a:extLst>
              <a:ext uri="{FF2B5EF4-FFF2-40B4-BE49-F238E27FC236}">
                <a16:creationId xmlns="" xmlns:a16="http://schemas.microsoft.com/office/drawing/2014/main" id="{923CC13B-3794-0D48-BDAE-D4BE7F2C54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92ACC-4BC5-674E-BD03-71A472ABDE82}" type="datetimeFigureOut">
              <a:rPr lang="ru-RU" smtClean="0"/>
              <a:t>26.11.2021</a:t>
            </a:fld>
            <a:endParaRPr lang="ru-RU"/>
          </a:p>
        </p:txBody>
      </p:sp>
      <p:sp>
        <p:nvSpPr>
          <p:cNvPr id="4" name="Нижний колонтитул 3">
            <a:extLst>
              <a:ext uri="{FF2B5EF4-FFF2-40B4-BE49-F238E27FC236}">
                <a16:creationId xmlns="" xmlns:a16="http://schemas.microsoft.com/office/drawing/2014/main" id="{03D9C3CD-E8EB-E54E-B55D-F14763E9BC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>
            <a:extLst>
              <a:ext uri="{FF2B5EF4-FFF2-40B4-BE49-F238E27FC236}">
                <a16:creationId xmlns="" xmlns:a16="http://schemas.microsoft.com/office/drawing/2014/main" id="{9E403F59-2837-1444-8EDA-38CD2C8986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94E17-15EA-254D-A7DA-47895961C57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5687191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>
            <a:extLst>
              <a:ext uri="{FF2B5EF4-FFF2-40B4-BE49-F238E27FC236}">
                <a16:creationId xmlns="" xmlns:a16="http://schemas.microsoft.com/office/drawing/2014/main" id="{16CC9CE5-81AF-D740-87C2-E99EC362B1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92ACC-4BC5-674E-BD03-71A472ABDE82}" type="datetimeFigureOut">
              <a:rPr lang="ru-RU" smtClean="0"/>
              <a:t>26.11.2021</a:t>
            </a:fld>
            <a:endParaRPr lang="ru-RU"/>
          </a:p>
        </p:txBody>
      </p:sp>
      <p:sp>
        <p:nvSpPr>
          <p:cNvPr id="3" name="Нижний колонтитул 2">
            <a:extLst>
              <a:ext uri="{FF2B5EF4-FFF2-40B4-BE49-F238E27FC236}">
                <a16:creationId xmlns="" xmlns:a16="http://schemas.microsoft.com/office/drawing/2014/main" id="{E14A5622-7570-0145-BC87-514A4A9AE4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>
            <a:extLst>
              <a:ext uri="{FF2B5EF4-FFF2-40B4-BE49-F238E27FC236}">
                <a16:creationId xmlns="" xmlns:a16="http://schemas.microsoft.com/office/drawing/2014/main" id="{7747B501-1547-054D-89C7-B547F3C8E0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94E17-15EA-254D-A7DA-47895961C57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2457816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57B806C8-9536-944C-8AE1-B43468C231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EBBC2817-C649-9747-8859-3729C417F02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Текст 3">
            <a:extLst>
              <a:ext uri="{FF2B5EF4-FFF2-40B4-BE49-F238E27FC236}">
                <a16:creationId xmlns="" xmlns:a16="http://schemas.microsoft.com/office/drawing/2014/main" id="{600E001A-AAE6-DE43-97F2-A3BBE94B43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="" xmlns:a16="http://schemas.microsoft.com/office/drawing/2014/main" id="{090E49EA-9724-F841-BE82-B58545B555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92ACC-4BC5-674E-BD03-71A472ABDE82}" type="datetimeFigureOut">
              <a:rPr lang="ru-RU" smtClean="0"/>
              <a:t>26.11.2021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="" xmlns:a16="http://schemas.microsoft.com/office/drawing/2014/main" id="{C590A7AC-495B-AB4E-ACE8-D8A3F65AB2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="" xmlns:a16="http://schemas.microsoft.com/office/drawing/2014/main" id="{8AFEB3EB-FE9C-8740-A96F-04198E6E65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94E17-15EA-254D-A7DA-47895961C57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8811876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FA742C37-4471-F045-8F86-54F166B2D4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Рисунок 2">
            <a:extLst>
              <a:ext uri="{FF2B5EF4-FFF2-40B4-BE49-F238E27FC236}">
                <a16:creationId xmlns="" xmlns:a16="http://schemas.microsoft.com/office/drawing/2014/main" id="{4C51C76D-4E07-7A40-A1D2-16D72A491C1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>
            <a:extLst>
              <a:ext uri="{FF2B5EF4-FFF2-40B4-BE49-F238E27FC236}">
                <a16:creationId xmlns="" xmlns:a16="http://schemas.microsoft.com/office/drawing/2014/main" id="{1FD1D3C8-5BFF-F245-9A1E-75D244DF36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="" xmlns:a16="http://schemas.microsoft.com/office/drawing/2014/main" id="{E1D3C48A-A3FC-884D-80FC-B63050AE16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92ACC-4BC5-674E-BD03-71A472ABDE82}" type="datetimeFigureOut">
              <a:rPr lang="ru-RU" smtClean="0"/>
              <a:t>26.11.2021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="" xmlns:a16="http://schemas.microsoft.com/office/drawing/2014/main" id="{04CBF30E-B028-D349-8626-95B934732A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="" xmlns:a16="http://schemas.microsoft.com/office/drawing/2014/main" id="{43437B67-E41B-414B-9560-3B0B440E4C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94E17-15EA-254D-A7DA-47895961C57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7182811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6E22E86D-C980-9D44-89A1-F66C50A91B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="" xmlns:a16="http://schemas.microsoft.com/office/drawing/2014/main" id="{60F9A6FA-7882-DF42-9057-8B25F13F1A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877FCA08-1233-784A-993F-720049D3668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592ACC-4BC5-674E-BD03-71A472ABDE82}" type="datetimeFigureOut">
              <a:rPr lang="ru-RU" smtClean="0"/>
              <a:t>26.11.2021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7A76F6CF-51EC-584E-855F-E247A369C68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5B394EA5-8A64-3A4C-8714-C586B20E784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D94E17-15EA-254D-A7DA-47895961C57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47478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tif"/><Relationship Id="rId4" Type="http://schemas.openxmlformats.org/officeDocument/2006/relationships/image" Target="../media/image8.ti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Группа 12">
            <a:extLst>
              <a:ext uri="{FF2B5EF4-FFF2-40B4-BE49-F238E27FC236}">
                <a16:creationId xmlns="" xmlns:a16="http://schemas.microsoft.com/office/drawing/2014/main" id="{075AEC36-89AE-B24C-9C6A-9EA943B51FB3}"/>
              </a:ext>
            </a:extLst>
          </p:cNvPr>
          <p:cNvGrpSpPr/>
          <p:nvPr/>
        </p:nvGrpSpPr>
        <p:grpSpPr>
          <a:xfrm>
            <a:off x="373118" y="774854"/>
            <a:ext cx="10556508" cy="4290067"/>
            <a:chOff x="373118" y="774854"/>
            <a:chExt cx="10556508" cy="4290067"/>
          </a:xfrm>
        </p:grpSpPr>
        <p:pic>
          <p:nvPicPr>
            <p:cNvPr id="14" name="Рисунок 13">
              <a:extLst>
                <a:ext uri="{FF2B5EF4-FFF2-40B4-BE49-F238E27FC236}">
                  <a16:creationId xmlns="" xmlns:a16="http://schemas.microsoft.com/office/drawing/2014/main" id="{50CB5C7F-1F24-B744-8CD5-C06EAB7FAFB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73118" y="774854"/>
              <a:ext cx="10556508" cy="4013068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="" xmlns:a16="http://schemas.microsoft.com/office/drawing/2014/main" id="{E0F184DD-98EF-084B-9CE6-66AC099486F6}"/>
                </a:ext>
              </a:extLst>
            </p:cNvPr>
            <p:cNvSpPr txBox="1"/>
            <p:nvPr/>
          </p:nvSpPr>
          <p:spPr>
            <a:xfrm>
              <a:off x="2831951" y="1542351"/>
              <a:ext cx="269309" cy="276999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l"/>
              <a:r>
                <a:rPr lang="ru-RU" sz="1200" dirty="0"/>
                <a:t>1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="" xmlns:a16="http://schemas.microsoft.com/office/drawing/2014/main" id="{F28B02B0-F0C6-1746-A058-E75D3259B25B}"/>
                </a:ext>
              </a:extLst>
            </p:cNvPr>
            <p:cNvSpPr txBox="1"/>
            <p:nvPr/>
          </p:nvSpPr>
          <p:spPr>
            <a:xfrm>
              <a:off x="1820777" y="2864260"/>
              <a:ext cx="1359607" cy="276999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l"/>
              <a:r>
                <a:rPr lang="en-US" sz="1200" dirty="0"/>
                <a:t>2 (GBR-NH</a:t>
              </a:r>
              <a:r>
                <a:rPr lang="en-US" sz="1200" baseline="-25000" dirty="0"/>
                <a:t>2</a:t>
              </a:r>
              <a:r>
                <a:rPr lang="en-US" sz="1200" dirty="0"/>
                <a:t>*HCl)</a:t>
              </a:r>
              <a:endParaRPr lang="ru-RU" sz="1200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="" xmlns:a16="http://schemas.microsoft.com/office/drawing/2014/main" id="{384DCD7D-A38D-7A4A-B974-26EF85BFCC49}"/>
                </a:ext>
              </a:extLst>
            </p:cNvPr>
            <p:cNvSpPr txBox="1"/>
            <p:nvPr/>
          </p:nvSpPr>
          <p:spPr>
            <a:xfrm>
              <a:off x="1088645" y="1633053"/>
              <a:ext cx="948182" cy="276999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l"/>
              <a:r>
                <a:rPr lang="en-US" sz="1200" dirty="0"/>
                <a:t>BODIPY-C3</a:t>
              </a:r>
              <a:endParaRPr lang="ru-RU" sz="1200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="" xmlns:a16="http://schemas.microsoft.com/office/drawing/2014/main" id="{18647E45-2EB2-7B48-A38F-884E5A709239}"/>
                </a:ext>
              </a:extLst>
            </p:cNvPr>
            <p:cNvSpPr txBox="1"/>
            <p:nvPr/>
          </p:nvSpPr>
          <p:spPr>
            <a:xfrm>
              <a:off x="4557713" y="2662655"/>
              <a:ext cx="269309" cy="276999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l"/>
              <a:r>
                <a:rPr lang="ru-RU" sz="1200" dirty="0"/>
                <a:t>1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="" xmlns:a16="http://schemas.microsoft.com/office/drawing/2014/main" id="{C6C31A76-2004-7642-95AE-189C250667C3}"/>
                </a:ext>
              </a:extLst>
            </p:cNvPr>
            <p:cNvSpPr txBox="1"/>
            <p:nvPr/>
          </p:nvSpPr>
          <p:spPr>
            <a:xfrm>
              <a:off x="9265920" y="2939654"/>
              <a:ext cx="269309" cy="276999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l"/>
              <a:r>
                <a:rPr lang="en-US" sz="1200" dirty="0"/>
                <a:t>3</a:t>
              </a:r>
              <a:endParaRPr lang="ru-RU" sz="1200" dirty="0"/>
            </a:p>
          </p:txBody>
        </p:sp>
        <p:sp>
          <p:nvSpPr>
            <p:cNvPr id="20" name="TextBox 19">
              <a:extLst>
                <a:ext uri="{FF2B5EF4-FFF2-40B4-BE49-F238E27FC236}">
                  <a16:creationId xmlns="" xmlns:a16="http://schemas.microsoft.com/office/drawing/2014/main" id="{35AC2196-73E9-FB4E-AC54-D22A765053B1}"/>
                </a:ext>
              </a:extLst>
            </p:cNvPr>
            <p:cNvSpPr txBox="1"/>
            <p:nvPr/>
          </p:nvSpPr>
          <p:spPr>
            <a:xfrm>
              <a:off x="1820777" y="4416391"/>
              <a:ext cx="269309" cy="276999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l"/>
              <a:r>
                <a:rPr lang="en-US" sz="1200" dirty="0"/>
                <a:t>2</a:t>
              </a:r>
              <a:endParaRPr lang="ru-RU" sz="1200" dirty="0"/>
            </a:p>
          </p:txBody>
        </p:sp>
        <p:sp>
          <p:nvSpPr>
            <p:cNvPr id="21" name="TextBox 20">
              <a:extLst>
                <a:ext uri="{FF2B5EF4-FFF2-40B4-BE49-F238E27FC236}">
                  <a16:creationId xmlns="" xmlns:a16="http://schemas.microsoft.com/office/drawing/2014/main" id="{F811DD3D-F5CA-804D-8E54-B3E1B870BFC4}"/>
                </a:ext>
              </a:extLst>
            </p:cNvPr>
            <p:cNvSpPr txBox="1"/>
            <p:nvPr/>
          </p:nvSpPr>
          <p:spPr>
            <a:xfrm>
              <a:off x="9011617" y="4277892"/>
              <a:ext cx="1283089" cy="276999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l"/>
              <a:r>
                <a:rPr lang="en-US" sz="1200" dirty="0"/>
                <a:t>4 (GBR-ATTO)</a:t>
              </a:r>
              <a:endParaRPr lang="ru-RU" sz="1200" dirty="0"/>
            </a:p>
          </p:txBody>
        </p:sp>
        <p:sp>
          <p:nvSpPr>
            <p:cNvPr id="22" name="TextBox 21">
              <a:extLst>
                <a:ext uri="{FF2B5EF4-FFF2-40B4-BE49-F238E27FC236}">
                  <a16:creationId xmlns="" xmlns:a16="http://schemas.microsoft.com/office/drawing/2014/main" id="{7957AD9C-C046-554F-99FC-913186279433}"/>
                </a:ext>
              </a:extLst>
            </p:cNvPr>
            <p:cNvSpPr txBox="1"/>
            <p:nvPr/>
          </p:nvSpPr>
          <p:spPr>
            <a:xfrm>
              <a:off x="4352930" y="4787922"/>
              <a:ext cx="1133469" cy="276999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200" dirty="0"/>
                <a:t>ATTO565-NHS </a:t>
              </a:r>
              <a:endParaRPr lang="ru-RU" sz="1200" dirty="0"/>
            </a:p>
          </p:txBody>
        </p:sp>
        <p:sp>
          <p:nvSpPr>
            <p:cNvPr id="23" name="TextBox 22">
              <a:extLst>
                <a:ext uri="{FF2B5EF4-FFF2-40B4-BE49-F238E27FC236}">
                  <a16:creationId xmlns="" xmlns:a16="http://schemas.microsoft.com/office/drawing/2014/main" id="{C902B96A-EA4C-5942-BC24-1264D2E9448E}"/>
                </a:ext>
              </a:extLst>
            </p:cNvPr>
            <p:cNvSpPr txBox="1"/>
            <p:nvPr/>
          </p:nvSpPr>
          <p:spPr>
            <a:xfrm>
              <a:off x="9011617" y="2927809"/>
              <a:ext cx="1778166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200" dirty="0"/>
                <a:t>(GBR-BODIPY)</a:t>
              </a:r>
              <a:endParaRPr lang="ru-RU" sz="1200" baseline="-25000" dirty="0"/>
            </a:p>
          </p:txBody>
        </p:sp>
      </p:grpSp>
      <p:sp>
        <p:nvSpPr>
          <p:cNvPr id="24" name="TextBox 23">
            <a:extLst>
              <a:ext uri="{FF2B5EF4-FFF2-40B4-BE49-F238E27FC236}">
                <a16:creationId xmlns="" xmlns:a16="http://schemas.microsoft.com/office/drawing/2014/main" id="{3BE1824D-D903-2343-B8FE-E00F902F48E9}"/>
              </a:ext>
            </a:extLst>
          </p:cNvPr>
          <p:cNvSpPr txBox="1"/>
          <p:nvPr/>
        </p:nvSpPr>
        <p:spPr>
          <a:xfrm>
            <a:off x="409254" y="5357763"/>
            <a:ext cx="11373492" cy="1146468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68580" tIns="34290" rIns="68580" bIns="3429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Scheme of the synthesis of fluorescent analogs of GBR-12909 with fluorophores BODIPY-C3 and ATTO-565. Reagents and conditions: </a:t>
            </a:r>
            <a:r>
              <a:rPr lang="ru-RU" sz="1400" dirty="0" err="1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a</a:t>
            </a:r>
            <a:r>
              <a:rPr lang="ru-RU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) </a:t>
            </a:r>
            <a:r>
              <a:rPr lang="ru-RU" sz="1400" dirty="0" err="1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i</a:t>
            </a:r>
            <a:r>
              <a:rPr lang="en-US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so-butyl chloroformate</a:t>
            </a:r>
            <a:r>
              <a:rPr lang="ru-RU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, Et</a:t>
            </a:r>
            <a:r>
              <a:rPr lang="ru-RU" sz="1400" baseline="-250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3</a:t>
            </a:r>
            <a:r>
              <a:rPr lang="ru-RU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N, </a:t>
            </a:r>
            <a:r>
              <a:rPr lang="ru-RU" sz="1400" dirty="0" err="1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MeCN</a:t>
            </a:r>
            <a:r>
              <a:rPr lang="ru-RU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, 4 °</a:t>
            </a:r>
            <a:r>
              <a:rPr lang="ru-RU" sz="1400" dirty="0" err="1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C</a:t>
            </a:r>
            <a:r>
              <a:rPr lang="ru-RU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, 10 </a:t>
            </a:r>
            <a:r>
              <a:rPr lang="ru-RU" sz="1400" dirty="0" err="1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min</a:t>
            </a:r>
            <a:r>
              <a:rPr lang="ru-RU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; </a:t>
            </a:r>
            <a:r>
              <a:rPr lang="ru-RU" sz="1400" dirty="0" err="1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b</a:t>
            </a:r>
            <a:r>
              <a:rPr lang="ru-RU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) Et</a:t>
            </a:r>
            <a:r>
              <a:rPr lang="ru-RU" sz="1400" baseline="-250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3</a:t>
            </a:r>
            <a:r>
              <a:rPr lang="ru-RU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N, </a:t>
            </a:r>
            <a:r>
              <a:rPr lang="ru-RU" sz="1400" dirty="0" err="1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MeCN</a:t>
            </a:r>
            <a:r>
              <a:rPr lang="ru-RU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, </a:t>
            </a:r>
            <a:r>
              <a:rPr lang="en-US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room temperature</a:t>
            </a:r>
            <a:r>
              <a:rPr lang="ru-RU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, 1 </a:t>
            </a:r>
            <a:r>
              <a:rPr lang="ru-RU" sz="1400" dirty="0" err="1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h</a:t>
            </a:r>
            <a:r>
              <a:rPr lang="ru-RU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; </a:t>
            </a:r>
            <a:r>
              <a:rPr lang="ru-RU" sz="1400" dirty="0" err="1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c</a:t>
            </a:r>
            <a:r>
              <a:rPr lang="ru-RU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) Et</a:t>
            </a:r>
            <a:r>
              <a:rPr lang="ru-RU" sz="1400" baseline="-250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3</a:t>
            </a:r>
            <a:r>
              <a:rPr lang="ru-RU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N, </a:t>
            </a:r>
            <a:r>
              <a:rPr lang="ru-RU" sz="1400" dirty="0" err="1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MeCN</a:t>
            </a:r>
            <a:r>
              <a:rPr lang="ru-RU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, </a:t>
            </a:r>
            <a:r>
              <a:rPr lang="en-US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room temperature</a:t>
            </a:r>
            <a:r>
              <a:rPr lang="ru-RU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, 12 </a:t>
            </a:r>
            <a:r>
              <a:rPr lang="ru-RU" sz="1400" dirty="0" err="1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h</a:t>
            </a:r>
            <a:r>
              <a:rPr lang="en-US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.</a:t>
            </a:r>
            <a:endParaRPr lang="ru-RU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ru-RU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ru-R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–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xed anhydride of BODIPY-C3 acid and </a:t>
            </a:r>
            <a:r>
              <a:rPr lang="ru-RU" sz="1400" dirty="0" err="1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i</a:t>
            </a:r>
            <a:r>
              <a:rPr lang="en-US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so-butyl chloroformate; 2 – novel modified analog of GBR12909, GBR-NH</a:t>
            </a:r>
            <a:r>
              <a:rPr lang="en-US" sz="1400" baseline="-250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2</a:t>
            </a:r>
            <a:r>
              <a:rPr lang="en-US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*HCl; 3 – novel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uorescent analog of GBR-12909 with BODIPY-C3 fluorophore, GBR-BODIPY; 4 –fluorescent analogs of GBR-12909 with ATTO-565</a:t>
            </a:r>
            <a:r>
              <a:rPr lang="en-US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uorophore, GBR-ATTO</a:t>
            </a:r>
            <a:endParaRPr lang="en-US" sz="1350" dirty="0"/>
          </a:p>
        </p:txBody>
      </p:sp>
    </p:spTree>
    <p:extLst>
      <p:ext uri="{BB962C8B-B14F-4D97-AF65-F5344CB8AC3E}">
        <p14:creationId xmlns:p14="http://schemas.microsoft.com/office/powerpoint/2010/main" val="41078329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Рисунок 3">
            <a:extLst>
              <a:ext uri="{FF2B5EF4-FFF2-40B4-BE49-F238E27FC236}">
                <a16:creationId xmlns="" xmlns:a16="http://schemas.microsoft.com/office/drawing/2014/main" id="{A6465593-F24C-4964-8317-F1F2CC969AF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9480" y="845382"/>
            <a:ext cx="8037174" cy="376319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765CAA63-A8F4-4EE5-A757-BFF94ABFBF64}"/>
              </a:ext>
            </a:extLst>
          </p:cNvPr>
          <p:cNvSpPr txBox="1"/>
          <p:nvPr/>
        </p:nvSpPr>
        <p:spPr>
          <a:xfrm>
            <a:off x="1827022" y="4945178"/>
            <a:ext cx="5968588" cy="1384995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68580" tIns="34290" rIns="68580" bIns="3429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a. High performance liquid chromatography of GBR-BP in a gradient system of 0.1% trifluoroacetic acid (TFA) in water- 100 % acetonitrile. 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omatography conditions. Chromatograph: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lichrom</a:t>
            </a:r>
            <a:r>
              <a:rPr lang="ru-R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™ А-0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coNov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ussia), Column:</a:t>
            </a:r>
            <a:r>
              <a:rPr lang="ru-R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ru-R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ntoSil</a:t>
            </a:r>
            <a:r>
              <a:rPr lang="ru-R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20-5-C18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ru-R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0 µ</a:t>
            </a:r>
            <a:r>
              <a:rPr lang="ru-R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ru-R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Q #2997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ru-R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.0x 75 </a:t>
            </a:r>
            <a:r>
              <a:rPr lang="ru-R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coNov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ussia), Eluent</a:t>
            </a:r>
            <a:r>
              <a:rPr lang="ru-R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ru-R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ru-R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ru-R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ru-R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ru-R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0.1% TF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Eluent</a:t>
            </a:r>
            <a:r>
              <a:rPr lang="ru-R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ru-R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ru-R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100%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etonitrile, Elution velocity</a:t>
            </a:r>
            <a:r>
              <a:rPr lang="ru-R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150.00 µ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lang="ru-R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n, Column temperature</a:t>
            </a:r>
            <a:r>
              <a:rPr lang="ru-R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40.0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℃.</a:t>
            </a:r>
            <a:r>
              <a:rPr lang="ru-R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endParaRPr lang="en-US" sz="1350" dirty="0"/>
          </a:p>
        </p:txBody>
      </p:sp>
    </p:spTree>
    <p:extLst>
      <p:ext uri="{BB962C8B-B14F-4D97-AF65-F5344CB8AC3E}">
        <p14:creationId xmlns:p14="http://schemas.microsoft.com/office/powerpoint/2010/main" val="425726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Рисунок 2">
            <a:extLst>
              <a:ext uri="{FF2B5EF4-FFF2-40B4-BE49-F238E27FC236}">
                <a16:creationId xmlns="" xmlns:a16="http://schemas.microsoft.com/office/drawing/2014/main" id="{2E924FA0-2358-4A0D-B57B-97B35022CF1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53391" y="262512"/>
            <a:ext cx="8081021" cy="377952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="" xmlns:a16="http://schemas.microsoft.com/office/drawing/2014/main" id="{2CFC4934-242A-4CCA-AE59-F27F207B47A5}"/>
              </a:ext>
            </a:extLst>
          </p:cNvPr>
          <p:cNvSpPr txBox="1"/>
          <p:nvPr/>
        </p:nvSpPr>
        <p:spPr>
          <a:xfrm>
            <a:off x="1070975" y="4245085"/>
            <a:ext cx="6288066" cy="1015663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68580" tIns="34290" rIns="68580" bIns="3429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b.  High performance liquid chromatography of GBR-ATTO in a gradient system of 0.1% trifluoroacetic acid (TFA) in water- 100 % acetonitrile. 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omatography conditions. Chromatograph: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lichrom</a:t>
            </a:r>
            <a:r>
              <a:rPr lang="ru-R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™ А-0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coNov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ussia), Column:</a:t>
            </a:r>
            <a:r>
              <a:rPr lang="ru-R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ru-R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ntoSil</a:t>
            </a:r>
            <a:r>
              <a:rPr lang="ru-R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20-5-C18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ru-R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0 µ</a:t>
            </a:r>
            <a:r>
              <a:rPr lang="ru-R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ru-R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Q #2997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ru-R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.0x 75 </a:t>
            </a:r>
            <a:r>
              <a:rPr lang="ru-R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coNov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ussia), Eluent</a:t>
            </a:r>
            <a:r>
              <a:rPr lang="ru-R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ru-R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ru-R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ru-R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ru-R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ru-R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0.1% TF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Eluent</a:t>
            </a:r>
            <a:r>
              <a:rPr lang="ru-R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ru-R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ru-R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100%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etonitrile, Elution velocity</a:t>
            </a:r>
            <a:r>
              <a:rPr lang="ru-R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150.00 µ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lang="ru-R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n, Column temperature</a:t>
            </a:r>
            <a:r>
              <a:rPr lang="ru-R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40.0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℃.</a:t>
            </a:r>
            <a:r>
              <a:rPr lang="ru-R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33567076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Рисунок 2">
            <a:extLst>
              <a:ext uri="{FF2B5EF4-FFF2-40B4-BE49-F238E27FC236}">
                <a16:creationId xmlns="" xmlns:a16="http://schemas.microsoft.com/office/drawing/2014/main" id="{E5683EB8-C52D-4E41-B217-866708EC9A7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2797" y="230743"/>
            <a:ext cx="7034954" cy="523127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="" xmlns:a16="http://schemas.microsoft.com/office/drawing/2014/main" id="{E29E648D-0ABE-4CEA-A979-9FE06453D95E}"/>
              </a:ext>
            </a:extLst>
          </p:cNvPr>
          <p:cNvSpPr txBox="1"/>
          <p:nvPr/>
        </p:nvSpPr>
        <p:spPr>
          <a:xfrm>
            <a:off x="3081297" y="5532903"/>
            <a:ext cx="6715845" cy="43858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68580" tIns="34290" rIns="68580" bIns="3429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a. Mass spectrometry of GBR-BP. Spectra were  recorded on an Orbitrap Q-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activ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us Thermo Scientific mass spectrometer (USA), electro spray ionization (ESI) in positive mode. </a:t>
            </a:r>
          </a:p>
        </p:txBody>
      </p:sp>
    </p:spTree>
    <p:extLst>
      <p:ext uri="{BB962C8B-B14F-4D97-AF65-F5344CB8AC3E}">
        <p14:creationId xmlns:p14="http://schemas.microsoft.com/office/powerpoint/2010/main" val="23556824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Рисунок 2">
            <a:extLst>
              <a:ext uri="{FF2B5EF4-FFF2-40B4-BE49-F238E27FC236}">
                <a16:creationId xmlns="" xmlns:a16="http://schemas.microsoft.com/office/drawing/2014/main" id="{A20BCDAC-A26F-4A49-8BF2-3173278CC6C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87168" y="611472"/>
            <a:ext cx="7266432" cy="536243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="" xmlns:a16="http://schemas.microsoft.com/office/drawing/2014/main" id="{E37A3337-F120-4014-B4CF-5D6BC36011D1}"/>
              </a:ext>
            </a:extLst>
          </p:cNvPr>
          <p:cNvSpPr txBox="1"/>
          <p:nvPr/>
        </p:nvSpPr>
        <p:spPr>
          <a:xfrm>
            <a:off x="3874389" y="5971794"/>
            <a:ext cx="4186110" cy="807913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68580" tIns="34290" rIns="68580" bIns="3429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b. Mass spectrometry of GBR-ATTO. Spectra were recorded on an Orbitrap Q-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activ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us Thermo Scientific mass spectrometer (USA), electro spray ionization (ESI) in positive mode. </a:t>
            </a:r>
          </a:p>
        </p:txBody>
      </p:sp>
    </p:spTree>
    <p:extLst>
      <p:ext uri="{BB962C8B-B14F-4D97-AF65-F5344CB8AC3E}">
        <p14:creationId xmlns:p14="http://schemas.microsoft.com/office/powerpoint/2010/main" val="13096506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Рисунок 2">
            <a:extLst>
              <a:ext uri="{FF2B5EF4-FFF2-40B4-BE49-F238E27FC236}">
                <a16:creationId xmlns="" xmlns:a16="http://schemas.microsoft.com/office/drawing/2014/main" id="{7B6DF0C0-0E6C-4D9A-A05B-A74BB7A71C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7789" y="172857"/>
            <a:ext cx="4852034" cy="2916502"/>
          </a:xfrm>
          <a:prstGeom prst="rect">
            <a:avLst/>
          </a:prstGeom>
        </p:spPr>
      </p:pic>
      <p:pic>
        <p:nvPicPr>
          <p:cNvPr id="4" name="Рисунок 4">
            <a:extLst>
              <a:ext uri="{FF2B5EF4-FFF2-40B4-BE49-F238E27FC236}">
                <a16:creationId xmlns="" xmlns:a16="http://schemas.microsoft.com/office/drawing/2014/main" id="{3A3D9188-0B08-4107-9BB5-AB693548E33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94807" y="3339155"/>
            <a:ext cx="4852035" cy="313022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="" xmlns:a16="http://schemas.microsoft.com/office/drawing/2014/main" id="{8B4FC149-A212-4033-9428-BDAA5A52F720}"/>
              </a:ext>
            </a:extLst>
          </p:cNvPr>
          <p:cNvSpPr txBox="1"/>
          <p:nvPr/>
        </p:nvSpPr>
        <p:spPr>
          <a:xfrm>
            <a:off x="1894807" y="3089359"/>
            <a:ext cx="8315993" cy="253916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68580" tIns="34290" rIns="68580" bIns="3429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S4a. Fluorescence and ultra-violet (absorption) spectra of GBR-BP (A) in comparison with spectra of BODIPY-C3 (B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="" xmlns:a16="http://schemas.microsoft.com/office/drawing/2014/main" id="{BA7D4E0A-959C-415A-BB2C-C05FBA0796B8}"/>
              </a:ext>
            </a:extLst>
          </p:cNvPr>
          <p:cNvSpPr txBox="1"/>
          <p:nvPr/>
        </p:nvSpPr>
        <p:spPr>
          <a:xfrm>
            <a:off x="1894807" y="6526409"/>
            <a:ext cx="8625693" cy="253916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68580" tIns="34290" rIns="68580" bIns="3429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b. Fluorescence and ultra-violet (absorption) spectra of GBR-ATTO (A) in comparison with spectra of ATTO-565-NHS (B)</a:t>
            </a:r>
          </a:p>
        </p:txBody>
      </p:sp>
      <p:pic>
        <p:nvPicPr>
          <p:cNvPr id="7" name="Рисунок 6">
            <a:extLst>
              <a:ext uri="{FF2B5EF4-FFF2-40B4-BE49-F238E27FC236}">
                <a16:creationId xmlns="" xmlns:a16="http://schemas.microsoft.com/office/drawing/2014/main" id="{CA774BA3-00E2-4F4B-889D-6007D90E3AA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26076" y="336180"/>
            <a:ext cx="4553836" cy="275317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="" xmlns:a16="http://schemas.microsoft.com/office/drawing/2014/main" id="{09F2404C-8ACC-F64D-B233-DF20B3AC7CC2}"/>
              </a:ext>
            </a:extLst>
          </p:cNvPr>
          <p:cNvSpPr txBox="1"/>
          <p:nvPr/>
        </p:nvSpPr>
        <p:spPr>
          <a:xfrm flipH="1">
            <a:off x="5442808" y="3624265"/>
            <a:ext cx="2543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  <a:endParaRPr lang="ru-RU" dirty="0"/>
          </a:p>
        </p:txBody>
      </p:sp>
      <p:sp>
        <p:nvSpPr>
          <p:cNvPr id="9" name="TextBox 8">
            <a:extLst>
              <a:ext uri="{FF2B5EF4-FFF2-40B4-BE49-F238E27FC236}">
                <a16:creationId xmlns="" xmlns:a16="http://schemas.microsoft.com/office/drawing/2014/main" id="{D95D7EEC-BA0C-E14E-9412-2294B6897CE2}"/>
              </a:ext>
            </a:extLst>
          </p:cNvPr>
          <p:cNvSpPr txBox="1"/>
          <p:nvPr/>
        </p:nvSpPr>
        <p:spPr>
          <a:xfrm>
            <a:off x="5125092" y="41227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  <a:endParaRPr lang="ru-RU" dirty="0"/>
          </a:p>
        </p:txBody>
      </p:sp>
      <p:sp>
        <p:nvSpPr>
          <p:cNvPr id="10" name="TextBox 9">
            <a:extLst>
              <a:ext uri="{FF2B5EF4-FFF2-40B4-BE49-F238E27FC236}">
                <a16:creationId xmlns="" xmlns:a16="http://schemas.microsoft.com/office/drawing/2014/main" id="{B7DE4D56-0F7E-0442-BB4C-7E94422C418E}"/>
              </a:ext>
            </a:extLst>
          </p:cNvPr>
          <p:cNvSpPr txBox="1"/>
          <p:nvPr/>
        </p:nvSpPr>
        <p:spPr>
          <a:xfrm>
            <a:off x="10210800" y="412277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  <a:endParaRPr lang="ru-RU" dirty="0"/>
          </a:p>
        </p:txBody>
      </p:sp>
      <p:pic>
        <p:nvPicPr>
          <p:cNvPr id="11" name="Рисунок 10">
            <a:extLst>
              <a:ext uri="{FF2B5EF4-FFF2-40B4-BE49-F238E27FC236}">
                <a16:creationId xmlns="" xmlns:a16="http://schemas.microsoft.com/office/drawing/2014/main" id="{CC713903-2C1F-F44B-A53E-D1C9A5CE8F0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2" t="1170" r="1095" b="1520"/>
          <a:stretch/>
        </p:blipFill>
        <p:spPr>
          <a:xfrm>
            <a:off x="6961297" y="3768641"/>
            <a:ext cx="4423807" cy="264555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="" xmlns:a16="http://schemas.microsoft.com/office/drawing/2014/main" id="{F99C74BF-2172-9D41-894C-4C2519622C6D}"/>
              </a:ext>
            </a:extLst>
          </p:cNvPr>
          <p:cNvSpPr txBox="1"/>
          <p:nvPr/>
        </p:nvSpPr>
        <p:spPr>
          <a:xfrm>
            <a:off x="10210800" y="3630513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  <a:endParaRPr lang="ru-RU" dirty="0"/>
          </a:p>
        </p:txBody>
      </p:sp>
    </p:spTree>
    <p:extLst>
      <p:ext uri="{BB962C8B-B14F-4D97-AF65-F5344CB8AC3E}">
        <p14:creationId xmlns:p14="http://schemas.microsoft.com/office/powerpoint/2010/main" val="417529423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Рисунок 2" descr="Изображение выглядит как стрела&#10;&#10;Автоматически созданное описание">
            <a:extLst>
              <a:ext uri="{FF2B5EF4-FFF2-40B4-BE49-F238E27FC236}">
                <a16:creationId xmlns="" xmlns:a16="http://schemas.microsoft.com/office/drawing/2014/main" id="{94207E50-B13B-4A53-8F4A-7BFF65BD98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67176" y="976301"/>
            <a:ext cx="4086223" cy="1339238"/>
          </a:xfrm>
          <a:prstGeom prst="rect">
            <a:avLst/>
          </a:prstGeom>
        </p:spPr>
      </p:pic>
      <p:pic>
        <p:nvPicPr>
          <p:cNvPr id="3" name="Рисунок 3">
            <a:extLst>
              <a:ext uri="{FF2B5EF4-FFF2-40B4-BE49-F238E27FC236}">
                <a16:creationId xmlns="" xmlns:a16="http://schemas.microsoft.com/office/drawing/2014/main" id="{0AEEFE7B-2542-412C-B634-32E472B3D19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50031" y="2919412"/>
            <a:ext cx="4086224" cy="149923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0988FC61-8CFA-4AC3-929F-9800185A5A83}"/>
              </a:ext>
            </a:extLst>
          </p:cNvPr>
          <p:cNvSpPr txBox="1"/>
          <p:nvPr/>
        </p:nvSpPr>
        <p:spPr>
          <a:xfrm>
            <a:off x="4090035" y="2480310"/>
            <a:ext cx="2057400" cy="2769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68580" tIns="34290" rIns="68580" bIns="3429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ru-RU" sz="1350" dirty="0"/>
              <a:t>GBR-BP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="" xmlns:a16="http://schemas.microsoft.com/office/drawing/2014/main" id="{70114EF4-8A3C-4EAC-88A0-972956DB28AC}"/>
              </a:ext>
            </a:extLst>
          </p:cNvPr>
          <p:cNvSpPr txBox="1"/>
          <p:nvPr/>
        </p:nvSpPr>
        <p:spPr>
          <a:xfrm>
            <a:off x="4088606" y="4501991"/>
            <a:ext cx="2057400" cy="2769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68580" tIns="34290" rIns="68580" bIns="3429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ru-RU" sz="1350" dirty="0"/>
              <a:t>GBR-ATTO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="" xmlns:a16="http://schemas.microsoft.com/office/drawing/2014/main" id="{6F404C7C-1420-1F41-8F29-D7926EE6F0AD}"/>
              </a:ext>
            </a:extLst>
          </p:cNvPr>
          <p:cNvSpPr txBox="1"/>
          <p:nvPr/>
        </p:nvSpPr>
        <p:spPr>
          <a:xfrm>
            <a:off x="3676615" y="5166118"/>
            <a:ext cx="53045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Optimized molecular models of fluorescent analogs GBR-12909. 3D images were performed using th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yMO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lecular Graphics System, Version 2.5.2 (Schrödinger, LLC, USA). </a:t>
            </a:r>
            <a:endParaRPr lang="ru-R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1322927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4</TotalTime>
  <Words>458</Words>
  <Application>Microsoft Office PowerPoint</Application>
  <PresentationFormat>Произвольный</PresentationFormat>
  <Paragraphs>27</Paragraphs>
  <Slides>7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7</vt:i4>
      </vt:variant>
    </vt:vector>
  </HeadingPairs>
  <TitlesOfParts>
    <vt:vector size="8" baseType="lpstr">
      <vt:lpstr>Тема Office</vt:lpstr>
      <vt:lpstr>Презентация PowerPoint</vt:lpstr>
      <vt:lpstr>Презентация PowerPoint</vt:lpstr>
      <vt:lpstr>Презентация PowerPoint</vt:lpstr>
      <vt:lpstr>Презентация PowerPoint</vt:lpstr>
      <vt:lpstr>Презентация PowerPoint</vt:lpstr>
      <vt:lpstr>Презентация PowerPoint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Владимир Безуглов</dc:creator>
  <cp:lastModifiedBy>Ugrumov</cp:lastModifiedBy>
  <cp:revision>17</cp:revision>
  <dcterms:created xsi:type="dcterms:W3CDTF">2021-10-01T20:46:18Z</dcterms:created>
  <dcterms:modified xsi:type="dcterms:W3CDTF">2021-11-26T07:28:24Z</dcterms:modified>
</cp:coreProperties>
</file>